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media/image9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445143-1F84-44FC-9978-96267879F3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8B7695-8685-4B6E-9EFE-A00971C8B6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D75D25-5F89-4AA9-ADA9-BB5D68B7F65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A4FA75-D726-44B9-A9C2-EB62528E06C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6ED3A9-6876-4E0B-8D15-33522F2B59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DC60CD-F49D-42A4-9E41-8A93FE40A4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FEC146-1847-4697-942B-CF40964A25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2EEB65-2C1A-4E90-8AC4-2770E48704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128520"/>
            <a:ext cx="8228160" cy="6646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4D4B3A-EFDF-4D1F-9848-90A91C5755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2D410E-5871-4C9C-AD13-C33097FBC2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D96408-4F7D-495F-952D-45F87D77D6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A59512-66C0-44F5-A96C-9AFB1D5951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1280" indent="-34128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1240" indent="-28404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7200" y="6245280"/>
            <a:ext cx="213192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3720" y="6245280"/>
            <a:ext cx="289404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5280"/>
            <a:ext cx="213228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fld id="{7E321F0B-556B-4FCA-9AF3-BDF6FD4F9103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image" Target="../media/image4.jpe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8.jpeg"/><Relationship Id="rId2" Type="http://schemas.openxmlformats.org/officeDocument/2006/relationships/image" Target="../media/image9.jpeg"/><Relationship Id="rId3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b2b2b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0" y="1628640"/>
            <a:ext cx="4527720" cy="369432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4572000" y="1628640"/>
            <a:ext cx="4572000" cy="371160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466560" y="5661000"/>
            <a:ext cx="76345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</a:rPr>
              <a:t>Alimentary plants. The young stem of a thistle (</a:t>
            </a:r>
            <a:r>
              <a:rPr b="1" i="1" lang="en-GB" sz="1600" spc="-1" strike="noStrike">
                <a:solidFill>
                  <a:srgbClr val="000000"/>
                </a:solidFill>
                <a:latin typeface="Arial"/>
              </a:rPr>
              <a:t>Carduus pycnocephalus </a:t>
            </a:r>
            <a:r>
              <a:rPr b="1" lang="en-GB" sz="1600" spc="-1" strike="noStrike">
                <a:solidFill>
                  <a:srgbClr val="000000"/>
                </a:solidFill>
                <a:latin typeface="Arial"/>
              </a:rPr>
              <a:t>Viv</a:t>
            </a:r>
            <a:r>
              <a:rPr b="1" i="1" lang="en-GB" sz="16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1" lang="en-GB" sz="1600" spc="-1" strike="noStrike">
                <a:solidFill>
                  <a:srgbClr val="000000"/>
                </a:solidFill>
                <a:latin typeface="Arial"/>
              </a:rPr>
              <a:t>) is peeled before being eaten as rural snack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b2b2b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431640" y="44280"/>
            <a:ext cx="8317080" cy="6786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6268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4211640" y="1031760"/>
            <a:ext cx="3240000" cy="766080"/>
          </a:xfrm>
          <a:prstGeom prst="rect">
            <a:avLst/>
          </a:prstGeom>
          <a:solidFill>
            <a:srgbClr val="ffffff">
              <a:alpha val="85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spcBef>
                <a:spcPts val="1125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3000"/>
              </a:lnSpc>
              <a:spcBef>
                <a:spcPts val="1125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332000" y="549360"/>
            <a:ext cx="576000" cy="348840"/>
          </a:xfrm>
          <a:prstGeom prst="rect">
            <a:avLst/>
          </a:prstGeom>
          <a:solidFill>
            <a:srgbClr val="ffffff">
              <a:alpha val="85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spcBef>
                <a:spcPts val="1125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it-IT" sz="1800" spc="-1" strike="noStrike">
                <a:solidFill>
                  <a:srgbClr val="ffffff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5003640" y="3429000"/>
            <a:ext cx="648000" cy="348840"/>
          </a:xfrm>
          <a:prstGeom prst="rect">
            <a:avLst/>
          </a:prstGeom>
          <a:solidFill>
            <a:srgbClr val="ffffff">
              <a:alpha val="85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spcBef>
                <a:spcPts val="1125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it-IT" sz="1800" spc="-1" strike="noStrike">
                <a:solidFill>
                  <a:srgbClr val="ffffff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2"/>
          <a:stretch/>
        </p:blipFill>
        <p:spPr>
          <a:xfrm>
            <a:off x="5940360" y="4459320"/>
            <a:ext cx="3132360" cy="2012760"/>
          </a:xfrm>
          <a:prstGeom prst="rect">
            <a:avLst/>
          </a:prstGeom>
          <a:ln w="12600">
            <a:solidFill>
              <a:srgbClr val="ffffff"/>
            </a:solidFill>
            <a:miter/>
          </a:ln>
        </p:spPr>
      </p:pic>
      <p:sp>
        <p:nvSpPr>
          <p:cNvPr id="50" name=""/>
          <p:cNvSpPr/>
          <p:nvPr/>
        </p:nvSpPr>
        <p:spPr>
          <a:xfrm>
            <a:off x="108000" y="6161040"/>
            <a:ext cx="59767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lants for ludic use. Children playing with the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bardofful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, a traditional spinning top made with different local wood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" descr=""/>
          <p:cNvPicPr/>
          <p:nvPr/>
        </p:nvPicPr>
        <p:blipFill>
          <a:blip r:embed="rId1"/>
          <a:stretch/>
        </p:blipFill>
        <p:spPr>
          <a:xfrm>
            <a:off x="-692280" y="22320"/>
            <a:ext cx="9872640" cy="684036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0" y="5950080"/>
            <a:ext cx="5977080" cy="580680"/>
          </a:xfrm>
          <a:prstGeom prst="rect">
            <a:avLst/>
          </a:prstGeom>
          <a:solidFill>
            <a:srgbClr val="ffffff">
              <a:alpha val="51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lants for ludic use. Children playing with horse-shaped toys made with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Arundo donax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826920" y="404640"/>
            <a:ext cx="4969080" cy="195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spcBef>
                <a:spcPts val="1125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3000"/>
              </a:lnSpc>
              <a:spcBef>
                <a:spcPts val="1125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3000"/>
              </a:lnSpc>
              <a:spcBef>
                <a:spcPts val="1125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3000"/>
              </a:lnSpc>
              <a:spcBef>
                <a:spcPts val="1125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3000"/>
              </a:lnSpc>
              <a:spcBef>
                <a:spcPts val="1125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900000" y="333360"/>
            <a:ext cx="4319640" cy="76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spcBef>
                <a:spcPts val="1125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3000"/>
              </a:lnSpc>
              <a:spcBef>
                <a:spcPts val="1125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981080" y="836640"/>
            <a:ext cx="3527640" cy="1144440"/>
          </a:xfrm>
          <a:prstGeom prst="rect">
            <a:avLst/>
          </a:prstGeom>
          <a:solidFill>
            <a:srgbClr val="ffffff">
              <a:alpha val="85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spcBef>
                <a:spcPts val="1125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it-IT" sz="1800" spc="-1" strike="noStrike">
                <a:solidFill>
                  <a:srgbClr val="ffffff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3000"/>
              </a:lnSpc>
              <a:spcBef>
                <a:spcPts val="1125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3000"/>
              </a:lnSpc>
              <a:spcBef>
                <a:spcPts val="1125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7885080" y="993600"/>
            <a:ext cx="792360" cy="348840"/>
          </a:xfrm>
          <a:prstGeom prst="rect">
            <a:avLst/>
          </a:prstGeom>
          <a:solidFill>
            <a:srgbClr val="ffffff">
              <a:alpha val="85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3000"/>
              </a:lnSpc>
              <a:spcBef>
                <a:spcPts val="1125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it-IT" sz="1800" spc="-1" strike="noStrike">
                <a:solidFill>
                  <a:srgbClr val="ffffff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bfbcad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" descr=""/>
          <p:cNvPicPr/>
          <p:nvPr/>
        </p:nvPicPr>
        <p:blipFill>
          <a:blip r:embed="rId1"/>
          <a:stretch/>
        </p:blipFill>
        <p:spPr>
          <a:xfrm>
            <a:off x="971640" y="-57240"/>
            <a:ext cx="7200720" cy="6942240"/>
          </a:xfrm>
          <a:prstGeom prst="rect">
            <a:avLst/>
          </a:prstGeom>
          <a:ln w="0">
            <a:noFill/>
          </a:ln>
        </p:spPr>
      </p:pic>
      <p:sp>
        <p:nvSpPr>
          <p:cNvPr id="58" name=""/>
          <p:cNvSpPr/>
          <p:nvPr/>
        </p:nvSpPr>
        <p:spPr>
          <a:xfrm>
            <a:off x="108000" y="6161040"/>
            <a:ext cx="45352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lants for ludic use. A little doll made with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Belli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,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Asphodelu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Malv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b2b2b2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" descr=""/>
          <p:cNvPicPr/>
          <p:nvPr/>
        </p:nvPicPr>
        <p:blipFill>
          <a:blip r:embed="rId1"/>
          <a:stretch/>
        </p:blipFill>
        <p:spPr>
          <a:xfrm>
            <a:off x="431640" y="0"/>
            <a:ext cx="8317080" cy="6850080"/>
          </a:xfrm>
          <a:prstGeom prst="rect">
            <a:avLst/>
          </a:prstGeom>
          <a:ln w="0">
            <a:noFill/>
          </a:ln>
        </p:spPr>
      </p:pic>
      <p:sp>
        <p:nvSpPr>
          <p:cNvPr id="60" name=""/>
          <p:cNvSpPr/>
          <p:nvPr/>
        </p:nvSpPr>
        <p:spPr>
          <a:xfrm>
            <a:off x="395280" y="6021360"/>
            <a:ext cx="37450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lants for ludic use. A necklace made with leaves of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Pinus pinaster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bfbcad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" descr=""/>
          <p:cNvPicPr/>
          <p:nvPr/>
        </p:nvPicPr>
        <p:blipFill>
          <a:blip r:embed="rId1"/>
          <a:stretch/>
        </p:blipFill>
        <p:spPr>
          <a:xfrm>
            <a:off x="-36360" y="-27000"/>
            <a:ext cx="4582800" cy="6985080"/>
          </a:xfrm>
          <a:prstGeom prst="rect">
            <a:avLst/>
          </a:prstGeom>
          <a:ln w="0">
            <a:noFill/>
          </a:ln>
        </p:spPr>
      </p:pic>
      <p:sp>
        <p:nvSpPr>
          <p:cNvPr id="62" name=""/>
          <p:cNvSpPr/>
          <p:nvPr/>
        </p:nvSpPr>
        <p:spPr>
          <a:xfrm>
            <a:off x="4608360" y="141120"/>
            <a:ext cx="453564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lants for religious use. Etiolated plants of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Triticum durum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are used to decorate the Holy Sepulchre on the Thursday before Easter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" descr=""/>
          <p:cNvPicPr/>
          <p:nvPr/>
        </p:nvPicPr>
        <p:blipFill>
          <a:blip r:embed="rId2"/>
          <a:stretch/>
        </p:blipFill>
        <p:spPr>
          <a:xfrm>
            <a:off x="4211640" y="3573360"/>
            <a:ext cx="4716360" cy="2979720"/>
          </a:xfrm>
          <a:prstGeom prst="rect">
            <a:avLst/>
          </a:prstGeom>
          <a:ln w="12600">
            <a:solidFill>
              <a:srgbClr val="ffffff"/>
            </a:solidFill>
            <a:miter/>
          </a:ln>
        </p:spPr>
      </p:pic>
    </p:spTree>
  </p:cSld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cdcbb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" descr=""/>
          <p:cNvPicPr/>
          <p:nvPr/>
        </p:nvPicPr>
        <p:blipFill>
          <a:blip r:embed="rId1"/>
          <a:stretch/>
        </p:blipFill>
        <p:spPr>
          <a:xfrm>
            <a:off x="539640" y="907920"/>
            <a:ext cx="3035520" cy="3168720"/>
          </a:xfrm>
          <a:prstGeom prst="rect">
            <a:avLst/>
          </a:prstGeom>
          <a:ln w="0">
            <a:noFill/>
          </a:ln>
        </p:spPr>
      </p:pic>
      <p:sp>
        <p:nvSpPr>
          <p:cNvPr id="65" name=""/>
          <p:cNvSpPr/>
          <p:nvPr/>
        </p:nvSpPr>
        <p:spPr>
          <a:xfrm>
            <a:off x="468360" y="5589720"/>
            <a:ext cx="8424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lants for handicraft use. Stools made with dried stems of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Ferula communi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Maria Adele Signorini</dc:creator>
  <dc:description/>
  <dc:language>en-US</dc:language>
  <cp:lastModifiedBy>Maria Adele Signorini</cp:lastModifiedBy>
  <dcterms:modified xsi:type="dcterms:W3CDTF">2009-01-27T08:55:12Z</dcterms:modified>
  <cp:revision>11</cp:revision>
  <dc:subject/>
  <dc:title>Diapositiva 1</dc:title>
</cp:coreProperties>
</file>